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0" r:id="rId2"/>
    <p:sldId id="322" r:id="rId3"/>
    <p:sldId id="324" r:id="rId4"/>
    <p:sldId id="325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BFD4C6-384C-F940-99D4-9505544E22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F5408AC-1224-A049-85D8-A49D3AAEE2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C3891CB-E969-7C45-A2F2-3764897DD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A55D80-3E91-2044-9797-AF01A4EEB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FCA869F-73CE-7046-B787-66E7FF8C9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8505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5C93AD5-BCF3-F74D-98F2-7220F0578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7009243-0E29-474F-B536-469FC3A887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555049A-6948-DD41-996B-092746066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0AAB543-B665-964A-8514-FE7EA5213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7C7F0FE-B918-7C41-BAED-B718B0A75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122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C555B7A-87CB-B24E-9395-5F30567A9C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31C11BA-488A-A641-BBD1-1FDB0AE153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AAFA29-9179-2F4E-9960-4583C95F9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AA6A05-3970-844A-8416-A840FC61A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1B2D498-7551-FF42-963F-C5664B082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3699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A824DA7-2510-8B49-B718-B8EE342F70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7746EF7-9963-E143-87A2-80DBB6335C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44CC5A9-49C4-254D-AA19-E4B3D6E6E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611741-4E4C-DA40-BDC7-F35BC7A5A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C1D0B1A-A049-714B-8565-2A8A4919C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2745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877D3FD-2967-4749-A793-0194D417F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FB3E8CE-D340-EC4F-AEE5-B5610ADAC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453E98D-32F3-934B-9107-766B56B0E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B72FD0D-6F55-7340-8866-4AA550B11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BF6004B-9164-C34D-A58B-5CB723611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5337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E2F529-6E09-FA42-8994-1457862292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237BB69-93FF-124B-8E58-E94EC8E80E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B9D1795-7C08-E646-A3B9-273A39033B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017F376-59CD-4D48-B524-C71E09253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A9EB127-9F2C-4544-8CC4-BCA615BB7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AD89DCC-CBEA-4647-BED9-0149538E5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6600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367756-F150-F441-A7DB-FFE4ED61D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E88537C-DC9A-3948-B07A-32910C189D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8FF67F3-C668-A047-A7EE-CC00626336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7C7B2E9-B34C-584C-A878-F9525DFEC0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5566CF5-F732-D348-A597-D705B5C01C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E19126C-BCFF-0643-B6D8-047E2D4CC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44EC1A7-F9DE-A349-AF15-5D6273BB8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02BCEEA-460F-A840-9BD3-ABDDC170F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7788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0FF11F-E31D-2643-8D8B-AB4DC7D08D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32520DE-50FF-ED4A-BF2B-94BC34235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45DD9AE-6F72-7447-96C2-5BDD0FAD7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5831190-405A-4846-A61F-2DB104D82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8321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DF94A33-2950-E443-9BCA-E6C7A01C0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A5514C3-8FAA-9E49-ACFF-93DB51C9C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AC53199-8C1C-6E4D-B022-40EC9A384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7937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3862031-A70C-4840-B0DB-BC954E10C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6C70B21-99A4-9344-8BFF-0D9B45FDB9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8BEC3F6-9CD0-7B44-89BE-CBD41760E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3DECC39-2E79-7748-9064-4A88E5F4C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AA18E4D-A610-874B-94FA-241F90F74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96CEBC7-1F9B-F54B-8426-F1A744F7F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5230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00C2B27-BDF5-D940-979F-50635DD1C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60D9428-9DB1-C144-A7CF-DA95D59A48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07B61FA-B0E0-C146-A08F-8377F0454F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4525623-50D2-244D-B13D-20AD90DC1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E094E1E-60D7-844F-A351-FAD1D063A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DE1296F-6FC8-9641-8797-F44717FC3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6427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BBD3A61-80DD-8348-8CF6-B01CC7396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FD62CFC-005C-4E47-BA25-8241A503AF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0DE5F60-801F-9743-A750-6F03B4382C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7C7F6-8D33-574D-9CB9-5ADB0D990830}" type="datetimeFigureOut">
              <a:rPr lang="it-IT" smtClean="0"/>
              <a:t>13/04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C9974DA-7F72-AA43-8527-DE5B9F2D4F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2AC85C9-A82F-3B44-B2C3-45ED2D6F30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7293C-4311-CD45-9B33-E7B230A714D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6109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Relationship Id="rId9" Type="http://schemas.openxmlformats.org/officeDocument/2006/relationships/image" Target="../media/image10.sv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EF85E65A-7D9C-D648-BC9B-CF46E0D499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2655" y="165050"/>
            <a:ext cx="5581985" cy="51460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ttangolo 1">
            <a:extLst>
              <a:ext uri="{FF2B5EF4-FFF2-40B4-BE49-F238E27FC236}">
                <a16:creationId xmlns:a16="http://schemas.microsoft.com/office/drawing/2014/main" id="{C8F4D6E0-AA08-D440-80EB-EFCAC32A4BC8}"/>
              </a:ext>
            </a:extLst>
          </p:cNvPr>
          <p:cNvSpPr/>
          <p:nvPr/>
        </p:nvSpPr>
        <p:spPr>
          <a:xfrm>
            <a:off x="1233791" y="5291351"/>
            <a:ext cx="10507493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-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it-IT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C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A) 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ew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 region  with fragment of </a:t>
            </a:r>
            <a:r>
              <a:rPr lang="pl-PL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C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nt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989C&gt;T 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p.Pro330L)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ctur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ated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GV, 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grativ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ic</a:t>
            </a:r>
            <a:r>
              <a:rPr lang="pl-PL" sz="1400">
                <a:latin typeface="Times New Roman" panose="02020603050405020304" pitchFamily="18" charset="0"/>
                <a:cs typeface="Times New Roman" panose="02020603050405020304" pitchFamily="18" charset="0"/>
              </a:rPr>
              <a:t> Viewer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ease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C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pl-PL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vers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V)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entation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’-5’),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efor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G&gt;A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titution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nger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ing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band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ent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 the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row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int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th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989C&gt;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iant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equently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so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the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verse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ientation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098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o 25">
            <a:extLst>
              <a:ext uri="{FF2B5EF4-FFF2-40B4-BE49-F238E27FC236}">
                <a16:creationId xmlns:a16="http://schemas.microsoft.com/office/drawing/2014/main" id="{6F80E813-3CCA-EF4A-8B66-B667A28A7E41}"/>
              </a:ext>
            </a:extLst>
          </p:cNvPr>
          <p:cNvGrpSpPr/>
          <p:nvPr/>
        </p:nvGrpSpPr>
        <p:grpSpPr>
          <a:xfrm>
            <a:off x="1668307" y="591034"/>
            <a:ext cx="8629758" cy="2384616"/>
            <a:chOff x="923066" y="1322406"/>
            <a:chExt cx="8629758" cy="2384616"/>
          </a:xfrm>
        </p:grpSpPr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6E40F381-AE2E-224A-BCC2-7D9E8F1859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1725" t="44532" r="14278" b="32660"/>
            <a:stretch/>
          </p:blipFill>
          <p:spPr>
            <a:xfrm>
              <a:off x="1699315" y="1729682"/>
              <a:ext cx="7478900" cy="1665911"/>
            </a:xfrm>
            <a:prstGeom prst="rect">
              <a:avLst/>
            </a:prstGeom>
          </p:spPr>
        </p:pic>
        <p:sp>
          <p:nvSpPr>
            <p:cNvPr id="11" name="Rettangolo arrotondato 121">
              <a:extLst>
                <a:ext uri="{FF2B5EF4-FFF2-40B4-BE49-F238E27FC236}">
                  <a16:creationId xmlns:a16="http://schemas.microsoft.com/office/drawing/2014/main" id="{E906E409-3D93-D644-835A-D7C096A4A837}"/>
                </a:ext>
              </a:extLst>
            </p:cNvPr>
            <p:cNvSpPr/>
            <p:nvPr/>
          </p:nvSpPr>
          <p:spPr>
            <a:xfrm>
              <a:off x="4857955" y="1890298"/>
              <a:ext cx="1821927" cy="193124"/>
            </a:xfrm>
            <a:prstGeom prst="roundRect">
              <a:avLst/>
            </a:prstGeom>
            <a:noFill/>
            <a:ln w="28575">
              <a:solidFill>
                <a:srgbClr val="0B59B2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" name="Rettangolo arrotondato 122">
              <a:extLst>
                <a:ext uri="{FF2B5EF4-FFF2-40B4-BE49-F238E27FC236}">
                  <a16:creationId xmlns:a16="http://schemas.microsoft.com/office/drawing/2014/main" id="{30D36864-2B41-3145-8806-8B324992B191}"/>
                </a:ext>
              </a:extLst>
            </p:cNvPr>
            <p:cNvSpPr/>
            <p:nvPr/>
          </p:nvSpPr>
          <p:spPr>
            <a:xfrm>
              <a:off x="5218240" y="2842946"/>
              <a:ext cx="1308132" cy="204804"/>
            </a:xfrm>
            <a:prstGeom prst="roundRect">
              <a:avLst/>
            </a:prstGeom>
            <a:noFill/>
            <a:ln w="19050">
              <a:solidFill>
                <a:srgbClr val="0B59B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" name="Rettangolo arrotondato 123">
              <a:extLst>
                <a:ext uri="{FF2B5EF4-FFF2-40B4-BE49-F238E27FC236}">
                  <a16:creationId xmlns:a16="http://schemas.microsoft.com/office/drawing/2014/main" id="{92FCD142-DC51-134C-9D3F-B0AB6C41C80B}"/>
                </a:ext>
              </a:extLst>
            </p:cNvPr>
            <p:cNvSpPr/>
            <p:nvPr/>
          </p:nvSpPr>
          <p:spPr>
            <a:xfrm>
              <a:off x="4981733" y="2141707"/>
              <a:ext cx="1537606" cy="193371"/>
            </a:xfrm>
            <a:prstGeom prst="roundRect">
              <a:avLst/>
            </a:prstGeom>
            <a:noFill/>
            <a:ln w="19050">
              <a:solidFill>
                <a:srgbClr val="0B59B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" name="Rettangolo arrotondato 124">
              <a:extLst>
                <a:ext uri="{FF2B5EF4-FFF2-40B4-BE49-F238E27FC236}">
                  <a16:creationId xmlns:a16="http://schemas.microsoft.com/office/drawing/2014/main" id="{F4FEDBFD-422F-6F44-B8A6-3E93BAC25548}"/>
                </a:ext>
              </a:extLst>
            </p:cNvPr>
            <p:cNvSpPr/>
            <p:nvPr/>
          </p:nvSpPr>
          <p:spPr>
            <a:xfrm>
              <a:off x="5218240" y="2608550"/>
              <a:ext cx="1301098" cy="204804"/>
            </a:xfrm>
            <a:prstGeom prst="roundRect">
              <a:avLst/>
            </a:prstGeom>
            <a:noFill/>
            <a:ln w="19050">
              <a:solidFill>
                <a:srgbClr val="0B59B2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" name="Rettangolo arrotondato 125">
              <a:extLst>
                <a:ext uri="{FF2B5EF4-FFF2-40B4-BE49-F238E27FC236}">
                  <a16:creationId xmlns:a16="http://schemas.microsoft.com/office/drawing/2014/main" id="{F70B0A58-7B9C-F64E-B8D8-6F9D1EF6353C}"/>
                </a:ext>
              </a:extLst>
            </p:cNvPr>
            <p:cNvSpPr/>
            <p:nvPr/>
          </p:nvSpPr>
          <p:spPr>
            <a:xfrm>
              <a:off x="4861584" y="2378004"/>
              <a:ext cx="1657754" cy="200405"/>
            </a:xfrm>
            <a:prstGeom prst="roundRect">
              <a:avLst/>
            </a:prstGeom>
            <a:noFill/>
            <a:ln w="19050">
              <a:solidFill>
                <a:srgbClr val="0B59B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0FBF815C-8552-A146-9E93-0208FC508BCD}"/>
                </a:ext>
              </a:extLst>
            </p:cNvPr>
            <p:cNvSpPr txBox="1"/>
            <p:nvPr/>
          </p:nvSpPr>
          <p:spPr>
            <a:xfrm>
              <a:off x="2992791" y="1322406"/>
              <a:ext cx="222528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0B59B2"/>
                  </a:solidFill>
                  <a:latin typeface="Arial" charset="0"/>
                  <a:ea typeface="Arial" charset="0"/>
                  <a:cs typeface="Arial" charset="0"/>
                </a:rPr>
                <a:t>flexible catalytic loop (</a:t>
              </a:r>
              <a:r>
                <a:rPr lang="en-GB" sz="1400" b="1" dirty="0">
                  <a:solidFill>
                    <a:srgbClr val="0B59B2"/>
                  </a:solidFill>
                  <a:latin typeface="Arial" charset="0"/>
                  <a:ea typeface="Arial" charset="0"/>
                  <a:cs typeface="Arial" charset="0"/>
                </a:rPr>
                <a:t>CL</a:t>
              </a:r>
              <a:r>
                <a:rPr lang="en-GB" sz="1400" dirty="0">
                  <a:solidFill>
                    <a:srgbClr val="0B59B2"/>
                  </a:solidFill>
                  <a:latin typeface="Arial" charset="0"/>
                  <a:ea typeface="Arial" charset="0"/>
                  <a:cs typeface="Arial" charset="0"/>
                </a:rPr>
                <a:t>)</a:t>
              </a:r>
            </a:p>
          </p:txBody>
        </p:sp>
        <p:cxnSp>
          <p:nvCxnSpPr>
            <p:cNvPr id="17" name="Connettore 2 16">
              <a:extLst>
                <a:ext uri="{FF2B5EF4-FFF2-40B4-BE49-F238E27FC236}">
                  <a16:creationId xmlns:a16="http://schemas.microsoft.com/office/drawing/2014/main" id="{55593976-C26D-EF41-931A-8BBCD65FBEAF}"/>
                </a:ext>
              </a:extLst>
            </p:cNvPr>
            <p:cNvCxnSpPr/>
            <p:nvPr/>
          </p:nvCxnSpPr>
          <p:spPr>
            <a:xfrm flipV="1">
              <a:off x="5506565" y="3224052"/>
              <a:ext cx="509" cy="204751"/>
            </a:xfrm>
            <a:prstGeom prst="straightConnector1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99FAB351-C84B-3D48-9D05-23AAA37CBCEE}"/>
                </a:ext>
              </a:extLst>
            </p:cNvPr>
            <p:cNvSpPr txBox="1"/>
            <p:nvPr/>
          </p:nvSpPr>
          <p:spPr>
            <a:xfrm>
              <a:off x="4214000" y="3399245"/>
              <a:ext cx="2589171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conserved catalytic tyrosine</a:t>
              </a:r>
            </a:p>
          </p:txBody>
        </p:sp>
        <p:cxnSp>
          <p:nvCxnSpPr>
            <p:cNvPr id="19" name="Connettore 1 18">
              <a:extLst>
                <a:ext uri="{FF2B5EF4-FFF2-40B4-BE49-F238E27FC236}">
                  <a16:creationId xmlns:a16="http://schemas.microsoft.com/office/drawing/2014/main" id="{8858635C-9519-EF4F-9288-2F9EFB1EBFF3}"/>
                </a:ext>
              </a:extLst>
            </p:cNvPr>
            <p:cNvCxnSpPr/>
            <p:nvPr/>
          </p:nvCxnSpPr>
          <p:spPr>
            <a:xfrm>
              <a:off x="4736080" y="1614150"/>
              <a:ext cx="236661" cy="204735"/>
            </a:xfrm>
            <a:prstGeom prst="line">
              <a:avLst/>
            </a:prstGeom>
            <a:ln w="28575">
              <a:solidFill>
                <a:srgbClr val="0B59B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2539F258-C8D9-3E40-958C-1B6CB80503A6}"/>
                </a:ext>
              </a:extLst>
            </p:cNvPr>
            <p:cNvSpPr txBox="1"/>
            <p:nvPr/>
          </p:nvSpPr>
          <p:spPr>
            <a:xfrm>
              <a:off x="923066" y="1820741"/>
              <a:ext cx="856325" cy="132343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AADC</a:t>
              </a:r>
            </a:p>
            <a:p>
              <a:r>
                <a:rPr lang="en-GB" sz="16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HDC</a:t>
              </a:r>
            </a:p>
            <a:p>
              <a:r>
                <a:rPr lang="en-GB" sz="16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CSAD</a:t>
              </a:r>
            </a:p>
            <a:p>
              <a:r>
                <a:rPr lang="en-GB" sz="16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GAD65</a:t>
              </a:r>
            </a:p>
            <a:p>
              <a:r>
                <a:rPr lang="en-GB" sz="16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GAD67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8B53A3D0-5BF4-E64D-8D20-3813D4D11AE7}"/>
                </a:ext>
              </a:extLst>
            </p:cNvPr>
            <p:cNvSpPr txBox="1"/>
            <p:nvPr/>
          </p:nvSpPr>
          <p:spPr>
            <a:xfrm>
              <a:off x="9026718" y="1808729"/>
              <a:ext cx="526106" cy="132343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charset="0"/>
                  <a:ea typeface="Arial" charset="0"/>
                  <a:cs typeface="Arial" charset="0"/>
                </a:rPr>
                <a:t>361</a:t>
              </a:r>
            </a:p>
            <a:p>
              <a:r>
                <a:rPr lang="en-GB" sz="1600" dirty="0">
                  <a:latin typeface="Arial" charset="0"/>
                  <a:ea typeface="Arial" charset="0"/>
                  <a:cs typeface="Arial" charset="0"/>
                </a:rPr>
                <a:t>361</a:t>
              </a:r>
            </a:p>
            <a:p>
              <a:r>
                <a:rPr lang="en-GB" sz="1600" dirty="0">
                  <a:latin typeface="Arial" charset="0"/>
                  <a:ea typeface="Arial" charset="0"/>
                  <a:cs typeface="Arial" charset="0"/>
                </a:rPr>
                <a:t>364</a:t>
              </a:r>
            </a:p>
            <a:p>
              <a:r>
                <a:rPr lang="en-GB" sz="1600" dirty="0">
                  <a:latin typeface="Arial" charset="0"/>
                  <a:ea typeface="Arial" charset="0"/>
                  <a:cs typeface="Arial" charset="0"/>
                </a:rPr>
                <a:t>454</a:t>
              </a:r>
            </a:p>
            <a:p>
              <a:r>
                <a:rPr lang="en-GB" sz="1600" dirty="0">
                  <a:latin typeface="Arial" charset="0"/>
                  <a:ea typeface="Arial" charset="0"/>
                  <a:cs typeface="Arial" charset="0"/>
                </a:rPr>
                <a:t>463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2EF32348-8A2D-3F47-B1B4-AF1D9FF8D449}"/>
                </a:ext>
              </a:extLst>
            </p:cNvPr>
            <p:cNvSpPr txBox="1"/>
            <p:nvPr/>
          </p:nvSpPr>
          <p:spPr>
            <a:xfrm>
              <a:off x="5416744" y="1471315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>
                  <a:solidFill>
                    <a:srgbClr val="F1382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330</a:t>
              </a:r>
            </a:p>
          </p:txBody>
        </p:sp>
        <p:cxnSp>
          <p:nvCxnSpPr>
            <p:cNvPr id="23" name="Connettore 1 22">
              <a:extLst>
                <a:ext uri="{FF2B5EF4-FFF2-40B4-BE49-F238E27FC236}">
                  <a16:creationId xmlns:a16="http://schemas.microsoft.com/office/drawing/2014/main" id="{BCA750E4-9C4F-D54E-9055-19C1F9F6AB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74997" y="1706111"/>
              <a:ext cx="197532" cy="156083"/>
            </a:xfrm>
            <a:prstGeom prst="line">
              <a:avLst/>
            </a:prstGeom>
            <a:ln w="28575">
              <a:solidFill>
                <a:srgbClr val="F1382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2 23">
              <a:extLst>
                <a:ext uri="{FF2B5EF4-FFF2-40B4-BE49-F238E27FC236}">
                  <a16:creationId xmlns:a16="http://schemas.microsoft.com/office/drawing/2014/main" id="{092071CA-112C-E844-9544-EA664953D949}"/>
                </a:ext>
              </a:extLst>
            </p:cNvPr>
            <p:cNvCxnSpPr/>
            <p:nvPr/>
          </p:nvCxnSpPr>
          <p:spPr>
            <a:xfrm flipV="1">
              <a:off x="1963617" y="3245188"/>
              <a:ext cx="509" cy="204751"/>
            </a:xfrm>
            <a:prstGeom prst="straightConnector1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B79A0A64-73E0-8043-9502-DEFEF136A593}"/>
                </a:ext>
              </a:extLst>
            </p:cNvPr>
            <p:cNvSpPr txBox="1"/>
            <p:nvPr/>
          </p:nvSpPr>
          <p:spPr>
            <a:xfrm>
              <a:off x="1261227" y="3392229"/>
              <a:ext cx="1794081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PLP-binding lysine</a:t>
              </a:r>
            </a:p>
          </p:txBody>
        </p:sp>
      </p:grp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B3AF6B8E-2937-4F45-98CC-8D05BD815A08}"/>
              </a:ext>
            </a:extLst>
          </p:cNvPr>
          <p:cNvSpPr txBox="1"/>
          <p:nvPr/>
        </p:nvSpPr>
        <p:spPr>
          <a:xfrm>
            <a:off x="2846995" y="779736"/>
            <a:ext cx="755079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ys303</a:t>
            </a:r>
          </a:p>
        </p:txBody>
      </p:sp>
      <p:cxnSp>
        <p:nvCxnSpPr>
          <p:cNvPr id="28" name="Connettore 1 27">
            <a:extLst>
              <a:ext uri="{FF2B5EF4-FFF2-40B4-BE49-F238E27FC236}">
                <a16:creationId xmlns:a16="http://schemas.microsoft.com/office/drawing/2014/main" id="{E67BA8C0-FF2C-4E4F-8226-171AB08AEA69}"/>
              </a:ext>
            </a:extLst>
          </p:cNvPr>
          <p:cNvCxnSpPr>
            <a:cxnSpLocks/>
          </p:cNvCxnSpPr>
          <p:nvPr/>
        </p:nvCxnSpPr>
        <p:spPr>
          <a:xfrm flipH="1">
            <a:off x="2705247" y="1014532"/>
            <a:ext cx="197532" cy="156083"/>
          </a:xfrm>
          <a:prstGeom prst="line">
            <a:avLst/>
          </a:prstGeom>
          <a:ln w="2857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ttangolo 1">
            <a:extLst>
              <a:ext uri="{FF2B5EF4-FFF2-40B4-BE49-F238E27FC236}">
                <a16:creationId xmlns:a16="http://schemas.microsoft.com/office/drawing/2014/main" id="{2EADC86C-31F8-2A43-A9E6-3FD22C90F71C}"/>
              </a:ext>
            </a:extLst>
          </p:cNvPr>
          <p:cNvSpPr/>
          <p:nvPr/>
        </p:nvSpPr>
        <p:spPr>
          <a:xfrm>
            <a:off x="670388" y="3691156"/>
            <a:ext cx="1062559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Multiple sequence alignment of the CL of group II PLP-dependent </a:t>
            </a:r>
            <a:r>
              <a:rPr lang="it-IT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carboxylases.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quences of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AD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20711),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HDC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19113)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CSAD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Q9Y600), hGAD65 (Q05329), hGAD67 (Q99259)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taken from the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Pro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atabase and aligned with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al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mega alignment. Amino acid one letter code is used. Dashes represents insertions and deletions. Invariant positions are indicated with *. Mobile CL is circled with a blue dashed line in correspondence to the part where electron density map is missing in the spatial solved structure. For AADC, conserved PLP-binding Lys303, conserved catalytic Tyr332 and Pro330 are indicated.  </a:t>
            </a:r>
            <a:endParaRPr lang="it-IT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08738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BF7A9667-50F4-224E-BD5B-F388B0969B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2863" y="292671"/>
            <a:ext cx="2496768" cy="227341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D992879D-611B-EF48-A788-A3036395F8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3901" y="292671"/>
            <a:ext cx="2496768" cy="2273415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CF5D959B-BCE9-FB47-A6A3-4D9C756A43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15509" y="292671"/>
            <a:ext cx="2488038" cy="2273415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74069F6-268D-144E-8F71-B19EAC4BFED5}"/>
              </a:ext>
            </a:extLst>
          </p:cNvPr>
          <p:cNvSpPr txBox="1"/>
          <p:nvPr/>
        </p:nvSpPr>
        <p:spPr>
          <a:xfrm>
            <a:off x="2221414" y="15913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pic>
        <p:nvPicPr>
          <p:cNvPr id="19" name="Immagine 18">
            <a:extLst>
              <a:ext uri="{FF2B5EF4-FFF2-40B4-BE49-F238E27FC236}">
                <a16:creationId xmlns:a16="http://schemas.microsoft.com/office/drawing/2014/main" id="{D57F620E-58EC-2D49-8C46-6051C76EC6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9164" y="2948789"/>
            <a:ext cx="2455495" cy="2239539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396050DA-0618-114A-AC4E-B75795D494A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70010" y="2951933"/>
            <a:ext cx="2455123" cy="2239200"/>
          </a:xfrm>
          <a:prstGeom prst="rect">
            <a:avLst/>
          </a:prstGeom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5E1D7C65-6903-964A-8AE4-6FFB409967D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73940" y="2949127"/>
            <a:ext cx="2535094" cy="2239200"/>
          </a:xfrm>
          <a:prstGeom prst="rect">
            <a:avLst/>
          </a:prstGeom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7208540-43E2-134C-BEB1-E10BC4943C2E}"/>
              </a:ext>
            </a:extLst>
          </p:cNvPr>
          <p:cNvSpPr txBox="1"/>
          <p:nvPr/>
        </p:nvSpPr>
        <p:spPr>
          <a:xfrm>
            <a:off x="2221414" y="270898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0D973423-42BC-2041-AD2E-1A44C335E1B7}"/>
              </a:ext>
            </a:extLst>
          </p:cNvPr>
          <p:cNvSpPr txBox="1"/>
          <p:nvPr/>
        </p:nvSpPr>
        <p:spPr>
          <a:xfrm>
            <a:off x="4618741" y="270898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B92CCB60-CEA0-5B42-B0AE-1E3B8248DB12}"/>
              </a:ext>
            </a:extLst>
          </p:cNvPr>
          <p:cNvSpPr txBox="1"/>
          <p:nvPr/>
        </p:nvSpPr>
        <p:spPr>
          <a:xfrm>
            <a:off x="6959779" y="270898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8116EBA3-87AE-A54A-8921-6CCF42B8EB50}"/>
              </a:ext>
            </a:extLst>
          </p:cNvPr>
          <p:cNvSpPr txBox="1"/>
          <p:nvPr/>
        </p:nvSpPr>
        <p:spPr>
          <a:xfrm>
            <a:off x="7606877" y="1742749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pH 8.5 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A99B68DF-AC11-D449-A6A9-70B52294EF09}"/>
              </a:ext>
            </a:extLst>
          </p:cNvPr>
          <p:cNvSpPr txBox="1"/>
          <p:nvPr/>
        </p:nvSpPr>
        <p:spPr>
          <a:xfrm>
            <a:off x="5180762" y="1742749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pH 7.5 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84D9B48C-0979-F445-B08F-082F3B94A231}"/>
              </a:ext>
            </a:extLst>
          </p:cNvPr>
          <p:cNvSpPr txBox="1"/>
          <p:nvPr/>
        </p:nvSpPr>
        <p:spPr>
          <a:xfrm>
            <a:off x="2885463" y="1742749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pH 6.5 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0CB2563D-09AB-BF4E-A0C6-81AC67AE3E1A}"/>
              </a:ext>
            </a:extLst>
          </p:cNvPr>
          <p:cNvSpPr txBox="1"/>
          <p:nvPr/>
        </p:nvSpPr>
        <p:spPr>
          <a:xfrm>
            <a:off x="3071761" y="699875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solidFill>
                  <a:srgbClr val="0B59B2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328 nm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B228E00A-DF45-A643-B218-8120F1CA5A81}"/>
              </a:ext>
            </a:extLst>
          </p:cNvPr>
          <p:cNvSpPr txBox="1"/>
          <p:nvPr/>
        </p:nvSpPr>
        <p:spPr>
          <a:xfrm>
            <a:off x="3933654" y="725533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solidFill>
                  <a:srgbClr val="0B59B2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20 nm</a:t>
            </a:r>
          </a:p>
        </p:txBody>
      </p:sp>
      <p:pic>
        <p:nvPicPr>
          <p:cNvPr id="28" name="Elemento grafico 27" descr="Freccia linea, diritta">
            <a:extLst>
              <a:ext uri="{FF2B5EF4-FFF2-40B4-BE49-F238E27FC236}">
                <a16:creationId xmlns:a16="http://schemas.microsoft.com/office/drawing/2014/main" id="{88B380EB-2ACE-2144-9E4B-98F1BAAD2CA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rot="5400000">
            <a:off x="2994083" y="692601"/>
            <a:ext cx="230832" cy="230832"/>
          </a:xfrm>
          <a:prstGeom prst="rect">
            <a:avLst/>
          </a:prstGeom>
        </p:spPr>
      </p:pic>
      <p:pic>
        <p:nvPicPr>
          <p:cNvPr id="29" name="Elemento grafico 28" descr="Freccia linea, diritta">
            <a:extLst>
              <a:ext uri="{FF2B5EF4-FFF2-40B4-BE49-F238E27FC236}">
                <a16:creationId xmlns:a16="http://schemas.microsoft.com/office/drawing/2014/main" id="{741074D7-15A9-584C-8FA0-CAB13ACE05F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rot="16200000">
            <a:off x="3851691" y="725533"/>
            <a:ext cx="230832" cy="230832"/>
          </a:xfrm>
          <a:prstGeom prst="rect">
            <a:avLst/>
          </a:prstGeom>
        </p:spPr>
      </p:pic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5F5E08B1-C246-A848-B491-C9FA8DB913B3}"/>
              </a:ext>
            </a:extLst>
          </p:cNvPr>
          <p:cNvSpPr txBox="1"/>
          <p:nvPr/>
        </p:nvSpPr>
        <p:spPr>
          <a:xfrm>
            <a:off x="5456508" y="674217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solidFill>
                  <a:srgbClr val="0B59B2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328 nm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2161831C-DABA-0E48-A575-5C5DF45ED951}"/>
              </a:ext>
            </a:extLst>
          </p:cNvPr>
          <p:cNvSpPr txBox="1"/>
          <p:nvPr/>
        </p:nvSpPr>
        <p:spPr>
          <a:xfrm>
            <a:off x="6282384" y="584459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solidFill>
                  <a:srgbClr val="0B59B2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20 nm</a:t>
            </a:r>
          </a:p>
        </p:txBody>
      </p:sp>
      <p:pic>
        <p:nvPicPr>
          <p:cNvPr id="32" name="Elemento grafico 31" descr="Freccia linea, diritta">
            <a:extLst>
              <a:ext uri="{FF2B5EF4-FFF2-40B4-BE49-F238E27FC236}">
                <a16:creationId xmlns:a16="http://schemas.microsoft.com/office/drawing/2014/main" id="{D318219F-C5A9-F34A-B082-739A3B1A599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rot="5400000">
            <a:off x="5378830" y="666943"/>
            <a:ext cx="230832" cy="230832"/>
          </a:xfrm>
          <a:prstGeom prst="rect">
            <a:avLst/>
          </a:prstGeom>
        </p:spPr>
      </p:pic>
      <p:pic>
        <p:nvPicPr>
          <p:cNvPr id="33" name="Elemento grafico 32" descr="Freccia linea, diritta">
            <a:extLst>
              <a:ext uri="{FF2B5EF4-FFF2-40B4-BE49-F238E27FC236}">
                <a16:creationId xmlns:a16="http://schemas.microsoft.com/office/drawing/2014/main" id="{E29F8E28-30AE-9345-B943-1B061FADFCF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rot="16200000">
            <a:off x="6200421" y="584459"/>
            <a:ext cx="230832" cy="230832"/>
          </a:xfrm>
          <a:prstGeom prst="rect">
            <a:avLst/>
          </a:prstGeom>
        </p:spPr>
      </p:pic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48993177-6805-8F48-9468-85200CA2E816}"/>
              </a:ext>
            </a:extLst>
          </p:cNvPr>
          <p:cNvSpPr txBox="1"/>
          <p:nvPr/>
        </p:nvSpPr>
        <p:spPr>
          <a:xfrm>
            <a:off x="8667131" y="666943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solidFill>
                  <a:srgbClr val="0B59B2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20 nm</a:t>
            </a:r>
          </a:p>
        </p:txBody>
      </p:sp>
      <p:pic>
        <p:nvPicPr>
          <p:cNvPr id="35" name="Elemento grafico 34" descr="Freccia linea, diritta">
            <a:extLst>
              <a:ext uri="{FF2B5EF4-FFF2-40B4-BE49-F238E27FC236}">
                <a16:creationId xmlns:a16="http://schemas.microsoft.com/office/drawing/2014/main" id="{6E29A724-2F35-534E-8091-999DC424BBE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rot="16200000">
            <a:off x="8585168" y="666943"/>
            <a:ext cx="230832" cy="230832"/>
          </a:xfrm>
          <a:prstGeom prst="rect">
            <a:avLst/>
          </a:prstGeom>
        </p:spPr>
      </p:pic>
      <p:sp>
        <p:nvSpPr>
          <p:cNvPr id="2" name="Rettangolo 1">
            <a:extLst>
              <a:ext uri="{FF2B5EF4-FFF2-40B4-BE49-F238E27FC236}">
                <a16:creationId xmlns:a16="http://schemas.microsoft.com/office/drawing/2014/main" id="{A55F29A6-171D-C140-9D9F-22B858F1AA56}"/>
              </a:ext>
            </a:extLst>
          </p:cNvPr>
          <p:cNvSpPr/>
          <p:nvPr/>
        </p:nvSpPr>
        <p:spPr>
          <a:xfrm>
            <a:off x="299460" y="5116258"/>
            <a:ext cx="10620403" cy="13696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Coenzyme modification during the catalysis of P330L with L-Dopa at different pH values.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 </a:t>
            </a:r>
            <a:r>
              <a:rPr lang="it-IT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 P330L was incubated with 2 mM L-Dopa in 50 mM bis-tris-propane buffer at pH 6.5, 7.5 and 8.5 at 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5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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 for 1 h and the reaction was analyzed by absorbance changes. At pH 8.5 the oxidation of the L-Dopa is not negligeable with time. </a:t>
            </a:r>
            <a:r>
              <a:rPr lang="en-US" sz="1400" b="1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mount of PLP content followed by HPLC analysis at the indicated pH values, concomitant with </a:t>
            </a:r>
            <a:r>
              <a:rPr lang="en-US" sz="1400" b="1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MP and PLP-L-Dopa adduct. </a:t>
            </a:r>
            <a:r>
              <a:rPr lang="en-US" sz="1400" b="1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r>
              <a:rPr lang="en-US" sz="1400" dirty="0">
                <a:solidFill>
                  <a:srgbClr val="1313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duction of dopamine at the indicated pH values.     </a:t>
            </a:r>
            <a:endParaRPr lang="it-IT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273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C7644DFB-B361-9349-BD88-B4A70510A4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6301" y="932910"/>
            <a:ext cx="3924300" cy="4330700"/>
          </a:xfrm>
          <a:prstGeom prst="rect">
            <a:avLst/>
          </a:prstGeom>
        </p:spPr>
      </p:pic>
      <p:sp>
        <p:nvSpPr>
          <p:cNvPr id="6" name="Rettangolo 5">
            <a:extLst>
              <a:ext uri="{FF2B5EF4-FFF2-40B4-BE49-F238E27FC236}">
                <a16:creationId xmlns:a16="http://schemas.microsoft.com/office/drawing/2014/main" id="{DB0BE7ED-2892-A945-ADA3-6E53E66CC381}"/>
              </a:ext>
            </a:extLst>
          </p:cNvPr>
          <p:cNvSpPr/>
          <p:nvPr/>
        </p:nvSpPr>
        <p:spPr>
          <a:xfrm>
            <a:off x="299460" y="5348009"/>
            <a:ext cx="10620403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Excitation spectra of coenzyme when emission is at 397 and/or 520 nm of WT and P330L AADC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it-IT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 WT (black lines) and P330L (blue lines) was incubated in 100 mM potassium phosphate buffer, pH = 7.5 and emission was set at both 397 nm and 520 nm to record the contribution of the tautomeric species to the fluorescence emission signals. </a:t>
            </a:r>
            <a:endParaRPr lang="it-IT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97669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1</TotalTime>
  <Words>454</Words>
  <Application>Microsoft Macintosh PowerPoint</Application>
  <PresentationFormat>Widescreen</PresentationFormat>
  <Paragraphs>33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rita Bertoldi</dc:creator>
  <cp:lastModifiedBy>Mariarita Bertoldi</cp:lastModifiedBy>
  <cp:revision>19</cp:revision>
  <dcterms:created xsi:type="dcterms:W3CDTF">2022-02-03T15:06:15Z</dcterms:created>
  <dcterms:modified xsi:type="dcterms:W3CDTF">2022-04-13T07:56:40Z</dcterms:modified>
</cp:coreProperties>
</file>